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9"/>
  </p:notesMasterIdLst>
  <p:sldIdLst>
    <p:sldId id="261" r:id="rId5"/>
    <p:sldId id="258" r:id="rId6"/>
    <p:sldId id="259" r:id="rId7"/>
    <p:sldId id="260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3447" autoAdjust="0"/>
  </p:normalViewPr>
  <p:slideViewPr>
    <p:cSldViewPr snapToGrid="0">
      <p:cViewPr>
        <p:scale>
          <a:sx n="80" d="100"/>
          <a:sy n="80" d="100"/>
        </p:scale>
        <p:origin x="147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ure 4 and S4'!$D$26</c:f>
              <c:strCache>
                <c:ptCount val="1"/>
                <c:pt idx="0">
                  <c:v>ctr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ure 4 and S4'!$F$27:$F$30</c:f>
                <c:numCache>
                  <c:formatCode>General</c:formatCode>
                  <c:ptCount val="4"/>
                  <c:pt idx="0">
                    <c:v>1.665994866761698E-2</c:v>
                  </c:pt>
                  <c:pt idx="1">
                    <c:v>8.6743935955286584E-3</c:v>
                  </c:pt>
                  <c:pt idx="2">
                    <c:v>1.1445163133370745E-2</c:v>
                  </c:pt>
                  <c:pt idx="3">
                    <c:v>7.6657471732450525E-3</c:v>
                  </c:pt>
                </c:numCache>
              </c:numRef>
            </c:plus>
            <c:minus>
              <c:numRef>
                <c:f>'Figure 4 and S4'!$F$27:$F$30</c:f>
                <c:numCache>
                  <c:formatCode>General</c:formatCode>
                  <c:ptCount val="4"/>
                  <c:pt idx="0">
                    <c:v>1.665994866761698E-2</c:v>
                  </c:pt>
                  <c:pt idx="1">
                    <c:v>8.6743935955286584E-3</c:v>
                  </c:pt>
                  <c:pt idx="2">
                    <c:v>1.1445163133370745E-2</c:v>
                  </c:pt>
                  <c:pt idx="3">
                    <c:v>7.665747173245052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ure 4 and S4'!$C$27:$C$30</c:f>
              <c:strCache>
                <c:ptCount val="4"/>
                <c:pt idx="0">
                  <c:v>PDO#1</c:v>
                </c:pt>
                <c:pt idx="1">
                  <c:v>PDO#2</c:v>
                </c:pt>
                <c:pt idx="2">
                  <c:v>PDO#3</c:v>
                </c:pt>
                <c:pt idx="3">
                  <c:v>PDO#4</c:v>
                </c:pt>
              </c:strCache>
            </c:strRef>
          </c:cat>
          <c:val>
            <c:numRef>
              <c:f>'Figure 4 and S4'!$D$27:$D$30</c:f>
              <c:numCache>
                <c:formatCode>General</c:formatCode>
                <c:ptCount val="4"/>
                <c:pt idx="0">
                  <c:v>0.92158293499999999</c:v>
                </c:pt>
                <c:pt idx="1">
                  <c:v>0.96322985934349992</c:v>
                </c:pt>
                <c:pt idx="2">
                  <c:v>0.90726475034999998</c:v>
                </c:pt>
                <c:pt idx="3">
                  <c:v>0.92635083146834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03-4476-AF14-79805D415407}"/>
            </c:ext>
          </c:extLst>
        </c:ser>
        <c:ser>
          <c:idx val="1"/>
          <c:order val="1"/>
          <c:tx>
            <c:strRef>
              <c:f>'Figure 4 and S4'!$E$26</c:f>
              <c:strCache>
                <c:ptCount val="1"/>
                <c:pt idx="0">
                  <c:v>5FU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ure 4 and S4'!$G$27:$G$30</c:f>
                <c:numCache>
                  <c:formatCode>General</c:formatCode>
                  <c:ptCount val="4"/>
                  <c:pt idx="0">
                    <c:v>1.826364421466866E-2</c:v>
                  </c:pt>
                  <c:pt idx="1">
                    <c:v>1.567681909388826E-2</c:v>
                  </c:pt>
                  <c:pt idx="2">
                    <c:v>1.3026038981977593E-2</c:v>
                  </c:pt>
                  <c:pt idx="3">
                    <c:v>1.4203025629735567E-2</c:v>
                  </c:pt>
                </c:numCache>
              </c:numRef>
            </c:plus>
            <c:minus>
              <c:numRef>
                <c:f>'Figure 4 and S4'!$G$27:$G$30</c:f>
                <c:numCache>
                  <c:formatCode>General</c:formatCode>
                  <c:ptCount val="4"/>
                  <c:pt idx="0">
                    <c:v>1.826364421466866E-2</c:v>
                  </c:pt>
                  <c:pt idx="1">
                    <c:v>1.567681909388826E-2</c:v>
                  </c:pt>
                  <c:pt idx="2">
                    <c:v>1.3026038981977593E-2</c:v>
                  </c:pt>
                  <c:pt idx="3">
                    <c:v>1.420302562973556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ure 4 and S4'!$C$27:$C$30</c:f>
              <c:strCache>
                <c:ptCount val="4"/>
                <c:pt idx="0">
                  <c:v>PDO#1</c:v>
                </c:pt>
                <c:pt idx="1">
                  <c:v>PDO#2</c:v>
                </c:pt>
                <c:pt idx="2">
                  <c:v>PDO#3</c:v>
                </c:pt>
                <c:pt idx="3">
                  <c:v>PDO#4</c:v>
                </c:pt>
              </c:strCache>
            </c:strRef>
          </c:cat>
          <c:val>
            <c:numRef>
              <c:f>'Figure 4 and S4'!$E$27:$E$30</c:f>
              <c:numCache>
                <c:formatCode>General</c:formatCode>
                <c:ptCount val="4"/>
                <c:pt idx="0">
                  <c:v>1.0102949999999999</c:v>
                </c:pt>
                <c:pt idx="1">
                  <c:v>1.7407995249999999</c:v>
                </c:pt>
                <c:pt idx="2">
                  <c:v>1.0325816999999999</c:v>
                </c:pt>
                <c:pt idx="3">
                  <c:v>1.0467514976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803-4476-AF14-79805D4154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0"/>
        <c:overlap val="-8"/>
        <c:axId val="390981663"/>
        <c:axId val="390980831"/>
      </c:barChart>
      <c:catAx>
        <c:axId val="390981663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sampl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90980831"/>
        <c:crosses val="autoZero"/>
        <c:auto val="1"/>
        <c:lblAlgn val="ctr"/>
        <c:lblOffset val="100"/>
        <c:noMultiLvlLbl val="0"/>
      </c:catAx>
      <c:valAx>
        <c:axId val="39098083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it-IT"/>
                  <a:t>RS scor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90981663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A24EC2-8CEF-4638-B44D-F0394C3C6285}" type="datetimeFigureOut">
              <a:rPr lang="it-IT" smtClean="0"/>
              <a:t>24/06/20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093C24-7E9A-40D0-8D5A-B3444A9652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912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C093C24-7E9A-40D0-8D5A-B3444A96525A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5439326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1a-b Representative dot plots of the PDOs#1-4 stained with anti-</a:t>
            </a:r>
            <a:r>
              <a:rPr lang="en-US" dirty="0" err="1"/>
              <a:t>EpCAM</a:t>
            </a:r>
            <a:r>
              <a:rPr lang="en-US" dirty="0"/>
              <a:t>,(a) anti-Ki67 (b), anti-CD44</a:t>
            </a:r>
            <a:r>
              <a:rPr lang="en-US" baseline="0" dirty="0"/>
              <a:t> c)</a:t>
            </a:r>
            <a:r>
              <a:rPr lang="en-US" dirty="0"/>
              <a:t> and anti-CK20(d),. The cells were stained at passage 0 (immediately after the disaggregation of the sourcing specimen) and at passage 3 . Initial gating was performed on live cells, as indicated in methods. Where available, an isotype-matched antibody was used to calculate the background staining. (lower panel).</a:t>
            </a: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093C24-7E9A-40D0-8D5A-B3444A96525A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493365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figure 1c-d Representative dot plots of the PDOs#1-4 stained with anti-</a:t>
            </a:r>
            <a:r>
              <a:rPr lang="en-US" dirty="0" err="1"/>
              <a:t>EpCAM</a:t>
            </a:r>
            <a:r>
              <a:rPr lang="en-US" dirty="0"/>
              <a:t>,(a) anti-Ki67 (b), anti-CD44</a:t>
            </a:r>
            <a:r>
              <a:rPr lang="en-US" baseline="0" dirty="0"/>
              <a:t> c)</a:t>
            </a:r>
            <a:r>
              <a:rPr lang="en-US" dirty="0"/>
              <a:t> and anti-CK20(d),. The cells were stained at passage 0 (immediately after the disaggregation of the sourcing specimen) and at passage 3 . Initial gating was performed on live cells, as indicated in methods. Where available, an isotype-matched antibody was used to calculate the background staining. (lower panel).</a:t>
            </a: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093C24-7E9A-40D0-8D5A-B3444A96525A}" type="slidenum">
              <a:rPr lang="it-IT" smtClean="0"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979240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</a:t>
            </a:r>
            <a:r>
              <a:rPr lang="en-US"/>
              <a:t>figure S2.</a:t>
            </a:r>
            <a:r>
              <a:rPr lang="en-US" baseline="0"/>
              <a:t> </a:t>
            </a:r>
            <a:r>
              <a:rPr lang="en-US" dirty="0"/>
              <a:t>. Graphs showing the RS score for the PDOs treated with ctrl (saline) or 5FU (6.25uM) for 72hrs. The RS score was obtained according to the following formula:  number of formed organoids x average max diameter x viable cells at time 0 day / number of organoids x average max diameter x viable cells after 72hrs, as described </a:t>
            </a:r>
            <a:r>
              <a:rPr lang="en-US" dirty="0" err="1"/>
              <a:t>i.n</a:t>
            </a:r>
            <a:r>
              <a:rPr lang="en-US" dirty="0"/>
              <a:t> the methods section. Statistics: * p&lt;0.05; ** p&gt;0.01; no asterisk: not significant. Please note that an RS score of  1 denotes</a:t>
            </a:r>
            <a:r>
              <a:rPr lang="en-US" baseline="0" dirty="0"/>
              <a:t> no effect.</a:t>
            </a:r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093C24-7E9A-40D0-8D5A-B3444A96525A}" type="slidenum">
              <a:rPr lang="it-IT" smtClean="0"/>
              <a:t>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995809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C1F06-2CE9-4757-B8BC-EEA32C51665D}" type="datetimeFigureOut">
              <a:rPr lang="it-IT" smtClean="0"/>
              <a:t>24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DF00-16A8-4FA3-A6AC-CCFF335EA1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30062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C1F06-2CE9-4757-B8BC-EEA32C51665D}" type="datetimeFigureOut">
              <a:rPr lang="it-IT" smtClean="0"/>
              <a:t>24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DF00-16A8-4FA3-A6AC-CCFF335EA1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79392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C1F06-2CE9-4757-B8BC-EEA32C51665D}" type="datetimeFigureOut">
              <a:rPr lang="it-IT" smtClean="0"/>
              <a:t>24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DF00-16A8-4FA3-A6AC-CCFF335EA1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4817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C1F06-2CE9-4757-B8BC-EEA32C51665D}" type="datetimeFigureOut">
              <a:rPr lang="it-IT" smtClean="0"/>
              <a:t>24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DF00-16A8-4FA3-A6AC-CCFF335EA1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71398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C1F06-2CE9-4757-B8BC-EEA32C51665D}" type="datetimeFigureOut">
              <a:rPr lang="it-IT" smtClean="0"/>
              <a:t>24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DF00-16A8-4FA3-A6AC-CCFF335EA1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70604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C1F06-2CE9-4757-B8BC-EEA32C51665D}" type="datetimeFigureOut">
              <a:rPr lang="it-IT" smtClean="0"/>
              <a:t>24/06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DF00-16A8-4FA3-A6AC-CCFF335EA1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441663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C1F06-2CE9-4757-B8BC-EEA32C51665D}" type="datetimeFigureOut">
              <a:rPr lang="it-IT" smtClean="0"/>
              <a:t>24/06/2023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DF00-16A8-4FA3-A6AC-CCFF335EA1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0738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C1F06-2CE9-4757-B8BC-EEA32C51665D}" type="datetimeFigureOut">
              <a:rPr lang="it-IT" smtClean="0"/>
              <a:t>24/06/2023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DF00-16A8-4FA3-A6AC-CCFF335EA1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561767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C1F06-2CE9-4757-B8BC-EEA32C51665D}" type="datetimeFigureOut">
              <a:rPr lang="it-IT" smtClean="0"/>
              <a:t>24/06/2023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DF00-16A8-4FA3-A6AC-CCFF335EA1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250913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C1F06-2CE9-4757-B8BC-EEA32C51665D}" type="datetimeFigureOut">
              <a:rPr lang="it-IT" smtClean="0"/>
              <a:t>24/06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DF00-16A8-4FA3-A6AC-CCFF335EA1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54129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C1F06-2CE9-4757-B8BC-EEA32C51665D}" type="datetimeFigureOut">
              <a:rPr lang="it-IT" smtClean="0"/>
              <a:t>24/06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DF00-16A8-4FA3-A6AC-CCFF335EA1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67232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BC1F06-2CE9-4757-B8BC-EEA32C51665D}" type="datetimeFigureOut">
              <a:rPr lang="it-IT" smtClean="0"/>
              <a:t>24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1BDF00-16A8-4FA3-A6AC-CCFF335EA1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6782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1EFED713-D14A-0D19-5973-EC78D5720EC3}"/>
              </a:ext>
            </a:extLst>
          </p:cNvPr>
          <p:cNvSpPr txBox="1"/>
          <p:nvPr/>
        </p:nvSpPr>
        <p:spPr>
          <a:xfrm>
            <a:off x="0" y="0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Figure S1</a:t>
            </a:r>
          </a:p>
        </p:txBody>
      </p:sp>
      <p:pic>
        <p:nvPicPr>
          <p:cNvPr id="8" name="Immagine 7">
            <a:extLst>
              <a:ext uri="{FF2B5EF4-FFF2-40B4-BE49-F238E27FC236}">
                <a16:creationId xmlns:a16="http://schemas.microsoft.com/office/drawing/2014/main" id="{32A2A8F8-5C81-90EE-8409-8CF6C0F60DB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70" t="5760" r="43412"/>
          <a:stretch/>
        </p:blipFill>
        <p:spPr>
          <a:xfrm>
            <a:off x="29427" y="1297808"/>
            <a:ext cx="3751146" cy="3276769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9B1CEE0E-608B-5460-8EBF-F81CE5E986C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1386" t="14286" r="470" b="14609"/>
          <a:stretch/>
        </p:blipFill>
        <p:spPr>
          <a:xfrm>
            <a:off x="3780573" y="1297808"/>
            <a:ext cx="3099123" cy="30052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80759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5746" y="975367"/>
            <a:ext cx="4502506" cy="3613709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170" y="5559477"/>
            <a:ext cx="4539082" cy="3551530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0" y="0"/>
            <a:ext cx="248939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figure S2</a:t>
            </a:r>
          </a:p>
          <a:p>
            <a:endParaRPr lang="it-IT" dirty="0"/>
          </a:p>
        </p:txBody>
      </p:sp>
      <p:sp>
        <p:nvSpPr>
          <p:cNvPr id="7" name="CasellaDiTesto 6"/>
          <p:cNvSpPr txBox="1"/>
          <p:nvPr/>
        </p:nvSpPr>
        <p:spPr>
          <a:xfrm flipH="1">
            <a:off x="198130" y="790701"/>
            <a:ext cx="701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a)</a:t>
            </a:r>
          </a:p>
        </p:txBody>
      </p:sp>
      <p:sp>
        <p:nvSpPr>
          <p:cNvPr id="8" name="CasellaDiTesto 7"/>
          <p:cNvSpPr txBox="1"/>
          <p:nvPr/>
        </p:nvSpPr>
        <p:spPr>
          <a:xfrm flipH="1">
            <a:off x="280436" y="5374811"/>
            <a:ext cx="701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3948730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4783" y="1008768"/>
            <a:ext cx="4667707" cy="3726607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1476" y="5877113"/>
            <a:ext cx="4611014" cy="2536058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 flipH="1">
            <a:off x="280436" y="5374811"/>
            <a:ext cx="701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d)</a:t>
            </a:r>
          </a:p>
        </p:txBody>
      </p:sp>
      <p:sp>
        <p:nvSpPr>
          <p:cNvPr id="7" name="CasellaDiTesto 6"/>
          <p:cNvSpPr txBox="1"/>
          <p:nvPr/>
        </p:nvSpPr>
        <p:spPr>
          <a:xfrm flipH="1">
            <a:off x="280436" y="1105672"/>
            <a:ext cx="701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c)</a:t>
            </a:r>
          </a:p>
        </p:txBody>
      </p:sp>
      <p:sp>
        <p:nvSpPr>
          <p:cNvPr id="8" name="CasellaDiTesto 7"/>
          <p:cNvSpPr txBox="1"/>
          <p:nvPr/>
        </p:nvSpPr>
        <p:spPr>
          <a:xfrm>
            <a:off x="0" y="0"/>
            <a:ext cx="2489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figure S2</a:t>
            </a:r>
          </a:p>
        </p:txBody>
      </p:sp>
    </p:spTree>
    <p:extLst>
      <p:ext uri="{BB962C8B-B14F-4D97-AF65-F5344CB8AC3E}">
        <p14:creationId xmlns:p14="http://schemas.microsoft.com/office/powerpoint/2010/main" val="39931541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7723008"/>
              </p:ext>
            </p:extLst>
          </p:nvPr>
        </p:nvGraphicFramePr>
        <p:xfrm>
          <a:off x="1092581" y="180301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CasellaDiTesto 5"/>
          <p:cNvSpPr txBox="1"/>
          <p:nvPr/>
        </p:nvSpPr>
        <p:spPr>
          <a:xfrm>
            <a:off x="0" y="0"/>
            <a:ext cx="2489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figure S3</a:t>
            </a:r>
          </a:p>
        </p:txBody>
      </p:sp>
      <p:cxnSp>
        <p:nvCxnSpPr>
          <p:cNvPr id="8" name="Connettore diritto 7"/>
          <p:cNvCxnSpPr/>
          <p:nvPr/>
        </p:nvCxnSpPr>
        <p:spPr>
          <a:xfrm flipV="1">
            <a:off x="1818025" y="2910923"/>
            <a:ext cx="3098042" cy="6824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CasellaDiTesto 8"/>
          <p:cNvSpPr txBox="1"/>
          <p:nvPr/>
        </p:nvSpPr>
        <p:spPr>
          <a:xfrm>
            <a:off x="2746072" y="1907853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**</a:t>
            </a:r>
          </a:p>
        </p:txBody>
      </p:sp>
      <p:grpSp>
        <p:nvGrpSpPr>
          <p:cNvPr id="10" name="Gruppo 9"/>
          <p:cNvGrpSpPr/>
          <p:nvPr/>
        </p:nvGrpSpPr>
        <p:grpSpPr>
          <a:xfrm>
            <a:off x="2841663" y="2121420"/>
            <a:ext cx="224316" cy="731701"/>
            <a:chOff x="2536293" y="3175292"/>
            <a:chExt cx="760431" cy="1073838"/>
          </a:xfrm>
        </p:grpSpPr>
        <p:cxnSp>
          <p:nvCxnSpPr>
            <p:cNvPr id="11" name="Connettore diritto 10"/>
            <p:cNvCxnSpPr/>
            <p:nvPr/>
          </p:nvCxnSpPr>
          <p:spPr>
            <a:xfrm>
              <a:off x="2536293" y="3177393"/>
              <a:ext cx="76043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nettore diritto 11"/>
            <p:cNvCxnSpPr/>
            <p:nvPr/>
          </p:nvCxnSpPr>
          <p:spPr>
            <a:xfrm>
              <a:off x="2543801" y="3175292"/>
              <a:ext cx="0" cy="107383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nettore diritto 12"/>
            <p:cNvCxnSpPr/>
            <p:nvPr/>
          </p:nvCxnSpPr>
          <p:spPr>
            <a:xfrm>
              <a:off x="3286925" y="3175292"/>
              <a:ext cx="0" cy="8191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83545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7DC2CDE34BB87479B9936A53DF00BD6" ma:contentTypeVersion="14" ma:contentTypeDescription="Create a new document." ma:contentTypeScope="" ma:versionID="554f19c74904c4110ef435a3a54015ec">
  <xsd:schema xmlns:xsd="http://www.w3.org/2001/XMLSchema" xmlns:xs="http://www.w3.org/2001/XMLSchema" xmlns:p="http://schemas.microsoft.com/office/2006/metadata/properties" xmlns:ns3="d193f1a8-93cd-481b-b4fd-b93e55c33ad4" xmlns:ns4="62186679-ca41-42dc-9d61-331464d79ae4" targetNamespace="http://schemas.microsoft.com/office/2006/metadata/properties" ma:root="true" ma:fieldsID="5a6870f9c990f9d5783a79fe28a997e5" ns3:_="" ns4:_="">
    <xsd:import namespace="d193f1a8-93cd-481b-b4fd-b93e55c33ad4"/>
    <xsd:import namespace="62186679-ca41-42dc-9d61-331464d79ae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193f1a8-93cd-481b-b4fd-b93e55c33ad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2186679-ca41-42dc-9d61-331464d79ae4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4F7AA25-C9D8-4AAC-9533-9859C3C767D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193f1a8-93cd-481b-b4fd-b93e55c33ad4"/>
    <ds:schemaRef ds:uri="62186679-ca41-42dc-9d61-331464d79ae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55C23FF9-EFDF-4DAA-AB34-DC5295B4B356}">
  <ds:schemaRefs>
    <ds:schemaRef ds:uri="http://purl.org/dc/terms/"/>
    <ds:schemaRef ds:uri="62186679-ca41-42dc-9d61-331464d79ae4"/>
    <ds:schemaRef ds:uri="http://www.w3.org/XML/1998/namespace"/>
    <ds:schemaRef ds:uri="http://schemas.microsoft.com/office/2006/metadata/properties"/>
    <ds:schemaRef ds:uri="http://purl.org/dc/elements/1.1/"/>
    <ds:schemaRef ds:uri="http://schemas.openxmlformats.org/package/2006/metadata/core-properties"/>
    <ds:schemaRef ds:uri="http://purl.org/dc/dcmitype/"/>
    <ds:schemaRef ds:uri="http://schemas.microsoft.com/office/2006/documentManagement/types"/>
    <ds:schemaRef ds:uri="http://schemas.microsoft.com/office/infopath/2007/PartnerControls"/>
    <ds:schemaRef ds:uri="d193f1a8-93cd-481b-b4fd-b93e55c33ad4"/>
  </ds:schemaRefs>
</ds:datastoreItem>
</file>

<file path=customXml/itemProps3.xml><?xml version="1.0" encoding="utf-8"?>
<ds:datastoreItem xmlns:ds="http://schemas.openxmlformats.org/officeDocument/2006/customXml" ds:itemID="{40E0EA95-FC5F-479B-9A37-E6D43F77E486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04</TotalTime>
  <Words>298</Words>
  <Application>Microsoft Office PowerPoint</Application>
  <PresentationFormat>A4 (21x29,7 cm)</PresentationFormat>
  <Paragraphs>18</Paragraphs>
  <Slides>4</Slides>
  <Notes>4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ioce Mario</dc:creator>
  <cp:lastModifiedBy>Cioce Mario</cp:lastModifiedBy>
  <cp:revision>25</cp:revision>
  <dcterms:created xsi:type="dcterms:W3CDTF">2023-02-09T11:50:07Z</dcterms:created>
  <dcterms:modified xsi:type="dcterms:W3CDTF">2023-06-24T13:10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7DC2CDE34BB87479B9936A53DF00BD6</vt:lpwstr>
  </property>
</Properties>
</file>